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782" autoAdjust="0"/>
    <p:restoredTop sz="94704" autoAdjust="0"/>
  </p:normalViewPr>
  <p:slideViewPr>
    <p:cSldViewPr>
      <p:cViewPr varScale="1">
        <p:scale>
          <a:sx n="154" d="100"/>
          <a:sy n="154" d="100"/>
        </p:scale>
        <p:origin x="1692" y="14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13996B-E296-46B2-A1F4-8200D110472D}" type="datetimeFigureOut">
              <a:rPr lang="en-GB" smtClean="0"/>
              <a:t>31/01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3638" y="1241425"/>
            <a:ext cx="44672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9963"/>
            <a:ext cx="5435600" cy="39100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10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A8F249-CF70-47CE-821B-D002A238EB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34696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44AB622-2E21-42BC-8333-403124448AFC}"/>
              </a:ext>
            </a:extLst>
          </p:cNvPr>
          <p:cNvSpPr txBox="1"/>
          <p:nvPr/>
        </p:nvSpPr>
        <p:spPr>
          <a:xfrm>
            <a:off x="228601" y="5269468"/>
            <a:ext cx="8534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. Metabolism of cholesterol </a:t>
            </a:r>
            <a:r>
              <a:rPr lang="en-GB"/>
              <a:t>through 5,6-EC</a:t>
            </a:r>
            <a:r>
              <a:rPr lang="en-GB" dirty="0"/>
              <a:t>, 7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α-HC, 24S-HC, 25-HC and 26-HC. R</a:t>
            </a:r>
            <a:r>
              <a:rPr lang="en-GB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 = OH in 24S-HC, 7</a:t>
            </a:r>
            <a:r>
              <a:rPr lang="el-GR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,24S-diHC and 7</a:t>
            </a:r>
            <a:r>
              <a:rPr lang="el-GR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,24S-diHCO. R</a:t>
            </a:r>
            <a:r>
              <a:rPr lang="en-GB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 = OH in 25-HC, 7</a:t>
            </a:r>
            <a:r>
              <a:rPr lang="el-GR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,25-diHC and 7</a:t>
            </a:r>
            <a:r>
              <a:rPr lang="el-GR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,25-diHCO. R</a:t>
            </a:r>
            <a:r>
              <a:rPr lang="en-GB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3 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= OH in 26-HC, 7α,26-diHC and 7</a:t>
            </a:r>
            <a:r>
              <a:rPr lang="el-GR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,26-diHCO. R</a:t>
            </a:r>
            <a:r>
              <a:rPr lang="en-GB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4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 = H or OH.   </a:t>
            </a:r>
            <a:endParaRPr lang="en-GB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50A9348-B7F9-45E6-BDD3-A3E239F6E6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2109881"/>
              </p:ext>
            </p:extLst>
          </p:nvPr>
        </p:nvGraphicFramePr>
        <p:xfrm>
          <a:off x="432319" y="762001"/>
          <a:ext cx="8273141" cy="4222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CS ChemDraw Drawing" r:id="rId3" imgW="9181350" imgH="4686976" progId="ChemDraw.Document.6.0">
                  <p:embed/>
                </p:oleObj>
              </mc:Choice>
              <mc:Fallback>
                <p:oleObj name="CS ChemDraw Drawing" r:id="rId3" imgW="9181350" imgH="4686976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2319" y="762001"/>
                        <a:ext cx="8273141" cy="4222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028142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6B08BD-38FE-441A-A20E-E84D33406108}"/>
              </a:ext>
            </a:extLst>
          </p:cNvPr>
          <p:cNvSpPr txBox="1"/>
          <p:nvPr/>
        </p:nvSpPr>
        <p:spPr>
          <a:xfrm>
            <a:off x="228601" y="6260068"/>
            <a:ext cx="853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2. Biosynthesis and metabolism of 7-DHC.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46F18AD-D278-48FC-A622-45729A6E9D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3447968"/>
              </p:ext>
            </p:extLst>
          </p:nvPr>
        </p:nvGraphicFramePr>
        <p:xfrm>
          <a:off x="879475" y="741363"/>
          <a:ext cx="7385050" cy="5376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CS ChemDraw Drawing" r:id="rId3" imgW="7384770" imgH="5376834" progId="ChemDraw.Document.6.0">
                  <p:embed/>
                </p:oleObj>
              </mc:Choice>
              <mc:Fallback>
                <p:oleObj name="CS ChemDraw Drawing" r:id="rId3" imgW="7384770" imgH="537683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79475" y="741363"/>
                        <a:ext cx="7385050" cy="5376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86464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1</TotalTime>
  <Words>81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Office Theme</vt:lpstr>
      <vt:lpstr>CS ChemDraw Drawing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iffiths W.J.</dc:creator>
  <cp:lastModifiedBy>w.j.griffiths</cp:lastModifiedBy>
  <cp:revision>56</cp:revision>
  <cp:lastPrinted>2018-01-26T11:59:36Z</cp:lastPrinted>
  <dcterms:created xsi:type="dcterms:W3CDTF">2006-08-16T00:00:00Z</dcterms:created>
  <dcterms:modified xsi:type="dcterms:W3CDTF">2018-01-31T05:36:55Z</dcterms:modified>
</cp:coreProperties>
</file>